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0" r:id="rId2"/>
    <p:sldId id="261" r:id="rId3"/>
    <p:sldId id="268" r:id="rId4"/>
    <p:sldId id="266" r:id="rId5"/>
    <p:sldId id="269" r:id="rId6"/>
  </p:sldIdLst>
  <p:sldSz cx="17068800" cy="9601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85" autoAdjust="0"/>
    <p:restoredTop sz="96233" autoAdjust="0"/>
  </p:normalViewPr>
  <p:slideViewPr>
    <p:cSldViewPr snapToGrid="0">
      <p:cViewPr varScale="1">
        <p:scale>
          <a:sx n="51" d="100"/>
          <a:sy n="51" d="100"/>
        </p:scale>
        <p:origin x="44" y="8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C0364-9339-43C9-86EB-4CC054442722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CC6BF-57CC-419A-BFEB-A95A6429B2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11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的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1850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1801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0127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0582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33600" y="1571308"/>
            <a:ext cx="1280160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33600" y="5042853"/>
            <a:ext cx="128016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383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715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214860" y="511175"/>
            <a:ext cx="3680460" cy="813657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73480" y="511175"/>
            <a:ext cx="10828020" cy="813657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918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740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4590" y="2393634"/>
            <a:ext cx="1472184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4590" y="6425249"/>
            <a:ext cx="1472184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601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734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410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99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3" y="511176"/>
            <a:ext cx="14721840" cy="1855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5704" y="2353628"/>
            <a:ext cx="7220902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75704" y="3507105"/>
            <a:ext cx="7220902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641080" y="2353628"/>
            <a:ext cx="7256463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641080" y="3507105"/>
            <a:ext cx="7256463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94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68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456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256463" y="1382396"/>
            <a:ext cx="864108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086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256463" y="1382396"/>
            <a:ext cx="864108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275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73480" y="511176"/>
            <a:ext cx="1472184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3480" y="2555875"/>
            <a:ext cx="1472184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7348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54040" y="8898891"/>
            <a:ext cx="576072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05484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647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9D34A2E0-CD12-625A-B2EB-0B9FFC808364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FB4803F-92C1-9185-15D4-385A7BBAE798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32ED90C-573F-4BE7-319F-435D1F4399B1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D257A13-288F-9BCE-29F3-3787E792309A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6935C3F-0001-935A-5D86-A2BF4B37DB92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49656AF3-BE2F-C50C-A09F-749B1635E79D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D980CA4-E49D-DEA6-0C27-F53D72DD17F5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8 (72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3 (92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A27D032-D778-7385-B696-6B7AF7E810D7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.0 months (3.0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9 months (2.1-4.6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FD369FA-F86D-469F-0FFB-F6B977F0790F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4 (0.21-0.79)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13307D8-2DE0-9C39-AB40-39C80D988329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8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DF9459C-2AA3-00E7-D12F-381B4B772753}"/>
                </a:ext>
              </a:extLst>
            </p:cNvPr>
            <p:cNvSpPr txBox="1"/>
            <p:nvPr/>
          </p:nvSpPr>
          <p:spPr>
            <a:xfrm>
              <a:off x="5498764" y="1280277"/>
              <a:ext cx="177484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latinum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2731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604C1FC-0DAE-EB8F-06C3-5C1E1DBCE6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033" y="0"/>
            <a:ext cx="16720734" cy="9601200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E6388AE3-AE79-0346-33D2-0144CC3AC6B3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1648A4EE-0BED-D147-88CA-0DE1257FCCAE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022020A-510C-46C7-6E06-938DEB58E443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729D852-4109-5AC2-2DE8-471EBDC2537C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39B4F6A-A022-FC01-5159-FC0CC43DAB9C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01A6DDA0-F6B5-2559-7D38-5DE409F12C99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47D917E-0E4A-AD20-53E1-FBBBE15E7BAE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4 (57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9 (96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D8E9954-A6FD-8174-0609-278C43FC22E8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4.9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.3 months (2.3-4.1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6D6D212-E59F-D714-AB7E-014B1D57B587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29 (0.17-0.49)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BB81B0C-C1A2-2348-0FD1-B9044E3A12B5}"/>
                </a:ext>
              </a:extLst>
            </p:cNvPr>
            <p:cNvSpPr txBox="1"/>
            <p:nvPr/>
          </p:nvSpPr>
          <p:spPr>
            <a:xfrm>
              <a:off x="14333003" y="1418776"/>
              <a:ext cx="960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F0CE54A-8777-853D-C6AC-C89462264DB3}"/>
                </a:ext>
              </a:extLst>
            </p:cNvPr>
            <p:cNvSpPr txBox="1"/>
            <p:nvPr/>
          </p:nvSpPr>
          <p:spPr>
            <a:xfrm>
              <a:off x="5498764" y="1280277"/>
              <a:ext cx="177484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latinum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66217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59D3BBAD-4ADF-1F68-18A3-63FB8C920E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033" y="0"/>
            <a:ext cx="16720734" cy="9601200"/>
          </a:xfrm>
          <a:prstGeom prst="rect">
            <a:avLst/>
          </a:prstGeom>
        </p:spPr>
      </p:pic>
      <p:grpSp>
        <p:nvGrpSpPr>
          <p:cNvPr id="16" name="组合 15">
            <a:extLst>
              <a:ext uri="{FF2B5EF4-FFF2-40B4-BE49-F238E27FC236}">
                <a16:creationId xmlns:a16="http://schemas.microsoft.com/office/drawing/2014/main" id="{2BBF1FDE-EBBD-41EC-A80C-E37A170BE3CC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8B54F7D-7080-EE58-7978-66CFB5201078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C7C0CC7-0035-A8C5-5629-67518B9E9BAA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5888AE4-2328-01AA-3035-055D7721E5A9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B36863E-733C-BD11-21A5-80C7D0679D80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A448A433-8DEC-8C99-C8A9-3C92278E8817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A92E265-0CAB-F02E-C5B5-6A6F63631DB6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8 (72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3 (92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8E6DED1C-6A58-1FD1-8397-8EB723451693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.0 months (3.0-NR)</a:t>
              </a:r>
            </a:p>
            <a:p>
              <a:r>
                <a:rPr lang="en-US" altLang="zh-CN">
                  <a:latin typeface="Arial" panose="020B0604020202020204" pitchFamily="34" charset="0"/>
                  <a:cs typeface="Arial" panose="020B0604020202020204" pitchFamily="34" charset="0"/>
                </a:rPr>
                <a:t>2.6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onths (2.1-4.6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9A38058-D2E1-348C-8A88-6A439E625797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41 (0.21-0.79)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E864322-3B75-4AAA-F35D-E69249CD9867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8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88364B1-C5ED-E22F-AEF9-02273E7EEDEB}"/>
                </a:ext>
              </a:extLst>
            </p:cNvPr>
            <p:cNvSpPr txBox="1"/>
            <p:nvPr/>
          </p:nvSpPr>
          <p:spPr>
            <a:xfrm>
              <a:off x="5498764" y="1280277"/>
              <a:ext cx="177484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latinum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图片 1">
            <a:extLst>
              <a:ext uri="{FF2B5EF4-FFF2-40B4-BE49-F238E27FC236}">
                <a16:creationId xmlns:a16="http://schemas.microsoft.com/office/drawing/2014/main" id="{154C7F51-D382-9B72-1107-B1216873AE9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97327"/>
          <a:stretch/>
        </p:blipFill>
        <p:spPr>
          <a:xfrm>
            <a:off x="180121" y="0"/>
            <a:ext cx="446896" cy="96012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3C98384-4141-C815-DFB5-271A6087354D}"/>
              </a:ext>
            </a:extLst>
          </p:cNvPr>
          <p:cNvSpPr txBox="1"/>
          <p:nvPr/>
        </p:nvSpPr>
        <p:spPr>
          <a:xfrm rot="10800000">
            <a:off x="157347" y="996191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529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7C32CD7-D022-46A9-9B41-DC3EF89B52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033" y="0"/>
            <a:ext cx="16720734" cy="9601200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12711943-D110-EE9A-6C60-196D2CDE22B9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648CD5E-AD53-CF5B-42F0-568F98815FC7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8870B32-8D20-D22B-4B7E-2A3AE013C3ED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C6D06FA-2CEB-A74C-783E-1DA527A3C403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0E97ABE-C626-B590-B47A-4992D2090B37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861F0DB2-04E7-7023-1ED6-6E6ECB927C51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3BF5261F-7BCA-34C7-B22B-C913BB718583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4 (33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2 (82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BEDC4CB-AEB1-DC96-521C-050713EC3A6B}"/>
                </a:ext>
              </a:extLst>
            </p:cNvPr>
            <p:cNvSpPr txBox="1"/>
            <p:nvPr/>
          </p:nvSpPr>
          <p:spPr>
            <a:xfrm>
              <a:off x="9643373" y="1280277"/>
              <a:ext cx="240322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8.7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2 months (7.4-13.1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79B69AC-F078-AC0A-BC9A-6955D49398CA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8 (0.20-0.72)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E45F56D-1D94-8127-81C9-5CACE13A5C54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3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C3F58DD1-A3E9-6871-9864-598B873B7948}"/>
                </a:ext>
              </a:extLst>
            </p:cNvPr>
            <p:cNvSpPr txBox="1"/>
            <p:nvPr/>
          </p:nvSpPr>
          <p:spPr>
            <a:xfrm>
              <a:off x="5498764" y="1280277"/>
              <a:ext cx="177484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latinum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4238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68468A3-BB0A-9B20-35A8-ACBB38FA65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033" y="0"/>
            <a:ext cx="16720734" cy="9601200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0F15EE05-7319-B0D0-023E-5CAACB0FF4E2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AD1C71A-2CEA-8BB8-E815-52E585C45AD2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8912D52-FE44-E7DC-4861-DDEB70D88870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980B72F-6BD4-9176-A2DE-731D9B7A4342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B39926F-A712-BAA7-F1A1-184B7F3FA9BC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9060528C-7441-1176-B3E7-FEACDA1E68D1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F8AC1AB-256C-89BD-AA9E-359298A17EC5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1 (44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9 (76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04DC57C-8903-1B4B-3D75-4668A06D4CB0}"/>
                </a:ext>
              </a:extLst>
            </p:cNvPr>
            <p:cNvSpPr txBox="1"/>
            <p:nvPr/>
          </p:nvSpPr>
          <p:spPr>
            <a:xfrm>
              <a:off x="9643373" y="1280277"/>
              <a:ext cx="240322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6.8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9 months (6.8-17.5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7BD40A7-A88F-642F-6662-78B74993E833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44 (0.20-0.99)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107DDB4-5600-CA57-9A00-7841D32A2CD7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47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90C99F6-C15C-DB9E-7DDE-49189BAE6E28}"/>
                </a:ext>
              </a:extLst>
            </p:cNvPr>
            <p:cNvSpPr txBox="1"/>
            <p:nvPr/>
          </p:nvSpPr>
          <p:spPr>
            <a:xfrm>
              <a:off x="5498764" y="1280277"/>
              <a:ext cx="177484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latinum based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0F200FF9-7C46-1C86-0B47-1E5A57F3C051}"/>
              </a:ext>
            </a:extLst>
          </p:cNvPr>
          <p:cNvSpPr txBox="1"/>
          <p:nvPr/>
        </p:nvSpPr>
        <p:spPr>
          <a:xfrm rot="10800000">
            <a:off x="152289" y="1557026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5912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4</TotalTime>
  <Words>226</Words>
  <Application>Microsoft Office PowerPoint</Application>
  <PresentationFormat>自定义</PresentationFormat>
  <Paragraphs>70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xi wang</dc:creator>
  <cp:lastModifiedBy>chenxi wang</cp:lastModifiedBy>
  <cp:revision>35</cp:revision>
  <dcterms:created xsi:type="dcterms:W3CDTF">2023-03-27T12:21:00Z</dcterms:created>
  <dcterms:modified xsi:type="dcterms:W3CDTF">2023-10-18T05:30:49Z</dcterms:modified>
</cp:coreProperties>
</file>